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B75A85-35D1-4C23-BD7C-F694EBFD549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6FA1C1-F0FB-4F12-B8DA-7A92EAF9E7D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1FD091C-79DE-4F4B-85C8-9DB492F1965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E2A314-31FF-467F-860C-62CB9B53497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EC2274-7D72-4E7A-97DA-FB369710AAE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FBFDA3-BD04-45F5-9125-F9B1A7ACDE8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C3AD5E-8537-4986-B8D3-DCDFC387CB3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17E7D5-4AAA-475B-83DE-3A1F23947A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428235-3237-41E2-A648-57BF77343A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7BFE8B-9D55-4019-BF45-FE0B967EFE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1D454A-40F9-4DB9-B15A-3BD28E0B8F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BB6CC-677F-4F4A-96D3-67206DAB933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B96CC80-1355-4323-8F2B-59FB2D9754DF}" type="datetime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20D8EF-952C-4693-9657-E697F4168923}" type="slidenum">
              <a:rPr b="0" lang="en-US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9"/>
          <p:cNvSpPr/>
          <p:nvPr/>
        </p:nvSpPr>
        <p:spPr>
          <a:xfrm>
            <a:off x="1413000" y="990720"/>
            <a:ext cx="3744720" cy="596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table 3: 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Evaluation of the association between the ANXA1 expression and clinical variables in invasive tumors of BCAC and </a:t>
            </a:r>
            <a:r>
              <a:rPr b="0" i="1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CA1|2</a:t>
            </a:r>
            <a:r>
              <a:rPr b="0" lang="en-US" sz="11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breast cancer patients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Object 1"/>
          <p:cNvGraphicFramePr/>
          <p:nvPr/>
        </p:nvGraphicFramePr>
        <p:xfrm>
          <a:off x="1413000" y="1908000"/>
          <a:ext cx="3800520" cy="60962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3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1413000" y="1908000"/>
                    <a:ext cx="3800520" cy="6096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0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1-01T11:57:37Z</dcterms:created>
  <dc:creator>Marcelo Sobral Leite</dc:creator>
  <dc:description/>
  <dc:language>en-US</dc:language>
  <cp:lastModifiedBy>Marcelo Sobral-Leite</cp:lastModifiedBy>
  <cp:lastPrinted>2014-09-08T08:30:29Z</cp:lastPrinted>
  <dcterms:modified xsi:type="dcterms:W3CDTF">2015-04-29T15:18:55Z</dcterms:modified>
  <cp:revision>413</cp:revision>
  <dc:subject/>
  <dc:title>Slide 1</dc:title>
</cp:coreProperties>
</file>